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2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OROZUMI NAOMI / 諸住 なおみ" initials="MN/諸な" lastIdx="1" clrIdx="0">
    <p:extLst>
      <p:ext uri="{19B8F6BF-5375-455C-9EA6-DF929625EA0E}">
        <p15:presenceInfo xmlns:p15="http://schemas.microsoft.com/office/powerpoint/2012/main" userId="S-1-5-21-2304227532-392271255-3195294537-8630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29" d="100"/>
          <a:sy n="129" d="100"/>
        </p:scale>
        <p:origin x="106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2" d="100"/>
        <a:sy n="6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Users\yotsuimy\Desktop\&#22823;&#24460;&#38957;&#23380;&#12288;&#25237;&#31295;&#21407;&#31295;\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umbar (Hprt)'!$B$74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Lumbar (Hprt)'!$B$90,'Lumbar (Hprt)'!$L$90,'Lumbar (Hprt)'!$V$90)</c:f>
                <c:numCache>
                  <c:formatCode>General</c:formatCode>
                  <c:ptCount val="3"/>
                  <c:pt idx="0">
                    <c:v>0.23962942718392505</c:v>
                  </c:pt>
                  <c:pt idx="1">
                    <c:v>6.2137021605668113E-2</c:v>
                  </c:pt>
                  <c:pt idx="2">
                    <c:v>0.326377649076259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Lumbar (Hprt)'!$A$70,'Lumbar (Hprt)'!$K$70,'Lumbar (Hprt)'!$U$70)</c:f>
              <c:strCache>
                <c:ptCount val="3"/>
                <c:pt idx="0">
                  <c:v>Mgp</c:v>
                </c:pt>
                <c:pt idx="1">
                  <c:v>Ank</c:v>
                </c:pt>
                <c:pt idx="2">
                  <c:v>Npp1</c:v>
                </c:pt>
              </c:strCache>
            </c:strRef>
          </c:cat>
          <c:val>
            <c:numRef>
              <c:f>('Lumbar (Hprt)'!$B$87,'Lumbar (Hprt)'!$L$87,'Lumbar (Hprt)'!$V$87)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'Lumbar (Hprt)'!$C$74</c:f>
              <c:strCache>
                <c:ptCount val="1"/>
                <c:pt idx="0">
                  <c:v>KO</c:v>
                </c:pt>
              </c:strCache>
            </c:strRef>
          </c:tx>
          <c:spPr>
            <a:noFill/>
            <a:ln w="15875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Lumbar (Hprt)'!$C$90,'Lumbar (Hprt)'!$M$90,'Lumbar (Hprt)'!$W$90)</c:f>
                <c:numCache>
                  <c:formatCode>General</c:formatCode>
                  <c:ptCount val="3"/>
                  <c:pt idx="0">
                    <c:v>8.4100102786798178E-3</c:v>
                  </c:pt>
                  <c:pt idx="1">
                    <c:v>0.20834183731441583</c:v>
                  </c:pt>
                  <c:pt idx="2">
                    <c:v>0.205181608412509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Lumbar (Hprt)'!$A$70,'Lumbar (Hprt)'!$K$70,'Lumbar (Hprt)'!$U$70)</c:f>
              <c:strCache>
                <c:ptCount val="3"/>
                <c:pt idx="0">
                  <c:v>Mgp</c:v>
                </c:pt>
                <c:pt idx="1">
                  <c:v>Ank</c:v>
                </c:pt>
                <c:pt idx="2">
                  <c:v>Npp1</c:v>
                </c:pt>
              </c:strCache>
            </c:strRef>
          </c:cat>
          <c:val>
            <c:numRef>
              <c:f>('Lumbar (Hprt)'!$C$87,'Lumbar (Hprt)'!$M$87,'Lumbar (Hprt)'!$W$87)</c:f>
              <c:numCache>
                <c:formatCode>General</c:formatCode>
                <c:ptCount val="3"/>
                <c:pt idx="0">
                  <c:v>0.48773918878856504</c:v>
                </c:pt>
                <c:pt idx="1">
                  <c:v>0.83287862671459545</c:v>
                </c:pt>
                <c:pt idx="2">
                  <c:v>0.8497698336612742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3900896"/>
        <c:axId val="377061624"/>
      </c:barChart>
      <c:catAx>
        <c:axId val="39008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defRPr>
            </a:pPr>
            <a:endParaRPr lang="ja-JP"/>
          </a:p>
        </c:txPr>
        <c:crossAx val="377061624"/>
        <c:crosses val="autoZero"/>
        <c:auto val="1"/>
        <c:lblAlgn val="ctr"/>
        <c:lblOffset val="100"/>
        <c:noMultiLvlLbl val="0"/>
      </c:catAx>
      <c:valAx>
        <c:axId val="377061624"/>
        <c:scaling>
          <c:orientation val="minMax"/>
          <c:max val="1.5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defRPr>
            </a:pPr>
            <a:endParaRPr lang="ja-JP"/>
          </a:p>
        </c:txPr>
        <c:crossAx val="3900896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400">
          <a:latin typeface="Arial Unicode MS" panose="020B0604020202020204" pitchFamily="50" charset="-128"/>
          <a:ea typeface="Arial Unicode MS" panose="020B0604020202020204" pitchFamily="50" charset="-128"/>
          <a:cs typeface="Arial Unicode MS" panose="020B0604020202020204" pitchFamily="50" charset="-128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59AEDA-2DDC-4B70-8EF5-0419D7FADD66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A24B99-A3BC-4461-BE44-DE9448BDE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30079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1C590-1F21-4D1B-ACA1-DC7260D60B0C}" type="datetime1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1043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BC8B8-99B4-46CD-95DE-0EB6F693136D}" type="datetime1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70704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07559-6167-4495-82F9-DD9DC21BEA66}" type="datetime1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8809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F297C-F96F-444B-87CB-1493F1A06D3A}" type="datetime1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9280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530B2-FA74-41C4-B322-A711F9C38547}" type="datetime1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6822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D83B8-E8DD-40DD-8339-02957856EB77}" type="datetime1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58220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B9DB1-C5A1-488D-9396-FFC2F32C1890}" type="datetime1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2686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0A8B0-6ED1-4664-940F-FC094A4E4710}" type="datetime1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01847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F395D7-ECD2-4F60-8F41-5EDD8644172C}" type="datetime1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3830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F9088-BA9C-4444-BBD4-C49C293E9248}" type="datetime1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30521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2B2B-1209-47FD-AE9B-9DC6AD32F07F}" type="datetime1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73022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5494E5-1475-4D96-8256-9D5A157CAFBF}" type="datetime1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0440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0" y="0"/>
            <a:ext cx="8788400" cy="1968500"/>
          </a:xfrm>
        </p:spPr>
        <p:txBody>
          <a:bodyPr>
            <a:noAutofit/>
          </a:bodyPr>
          <a:lstStyle/>
          <a:p>
            <a:r>
              <a:rPr lang="en-US" altLang="ja-JP" sz="3200" b="1" dirty="0"/>
              <a:t>Supplement </a:t>
            </a:r>
            <a:r>
              <a:rPr lang="en-US" altLang="ja-JP" sz="3200" b="1" dirty="0" smtClean="0"/>
              <a:t>fig 2</a:t>
            </a:r>
            <a:r>
              <a:rPr lang="ja-JP" altLang="ja-JP" sz="1800" dirty="0"/>
              <a:t/>
            </a:r>
            <a:br>
              <a:rPr lang="ja-JP" altLang="ja-JP" sz="1800" dirty="0"/>
            </a:br>
            <a:r>
              <a:rPr lang="en-US" altLang="ja-JP" sz="1800" b="1" dirty="0" smtClean="0"/>
              <a:t>Comparison of gene expression of </a:t>
            </a:r>
            <a:r>
              <a:rPr lang="en-US" altLang="ja-JP" sz="1800" b="1" i="1" dirty="0" err="1" smtClean="0"/>
              <a:t>Mgp</a:t>
            </a:r>
            <a:r>
              <a:rPr lang="en-US" altLang="ja-JP" sz="1800" b="1" dirty="0" smtClean="0"/>
              <a:t>, </a:t>
            </a:r>
            <a:r>
              <a:rPr lang="en-US" altLang="ja-JP" sz="1800" b="1" i="1" dirty="0" err="1" smtClean="0"/>
              <a:t>Ank</a:t>
            </a:r>
            <a:r>
              <a:rPr lang="en-US" altLang="ja-JP" sz="1800" b="1" dirty="0" smtClean="0"/>
              <a:t> and </a:t>
            </a:r>
            <a:r>
              <a:rPr lang="en-US" altLang="ja-JP" sz="1800" b="1" i="1" dirty="0" smtClean="0"/>
              <a:t>Npp1</a:t>
            </a:r>
            <a:r>
              <a:rPr lang="en-US" altLang="ja-JP" sz="1800" b="1" dirty="0" smtClean="0"/>
              <a:t> between </a:t>
            </a:r>
            <a:r>
              <a:rPr lang="en-US" altLang="ja-JP" sz="1800" b="1" dirty="0"/>
              <a:t>WT and CNP-KO rats. </a:t>
            </a:r>
            <a:r>
              <a:rPr lang="ja-JP" altLang="ja-JP" sz="1800" b="1" dirty="0" smtClean="0"/>
              <a:t/>
            </a:r>
            <a:br>
              <a:rPr lang="ja-JP" altLang="ja-JP" sz="1800" b="1" dirty="0" smtClean="0"/>
            </a:br>
            <a:r>
              <a:rPr lang="en-US" altLang="ja-JP" sz="1800" dirty="0" smtClean="0"/>
              <a:t>RT-PCR of </a:t>
            </a:r>
            <a:r>
              <a:rPr lang="en-US" altLang="ja-JP" sz="1800" dirty="0"/>
              <a:t>the mineralization inhibitor regulating </a:t>
            </a:r>
            <a:r>
              <a:rPr lang="en-US" altLang="ja-JP" sz="1800" dirty="0" smtClean="0"/>
              <a:t>genes, </a:t>
            </a:r>
            <a:r>
              <a:rPr lang="en-US" altLang="ja-JP" sz="1800" i="1" dirty="0" err="1" smtClean="0"/>
              <a:t>Mgp</a:t>
            </a:r>
            <a:r>
              <a:rPr lang="en-US" altLang="ja-JP" sz="1800" dirty="0" smtClean="0"/>
              <a:t>, </a:t>
            </a:r>
            <a:r>
              <a:rPr lang="en-US" altLang="ja-JP" sz="1800" i="1" dirty="0" err="1" smtClean="0"/>
              <a:t>Ank</a:t>
            </a:r>
            <a:r>
              <a:rPr lang="en-US" altLang="ja-JP" sz="1800" dirty="0" smtClean="0"/>
              <a:t> and </a:t>
            </a:r>
            <a:r>
              <a:rPr lang="en-US" altLang="ja-JP" sz="1800" i="1" dirty="0" smtClean="0"/>
              <a:t>Npp1</a:t>
            </a:r>
            <a:r>
              <a:rPr lang="en-US" altLang="ja-JP" sz="1800" dirty="0" smtClean="0"/>
              <a:t> in lumber vertebra of 4-week-old female WT and CNP-KO rats</a:t>
            </a:r>
            <a:r>
              <a:rPr lang="en-US" altLang="ja-JP" sz="1800" dirty="0"/>
              <a:t>. </a:t>
            </a:r>
            <a:r>
              <a:rPr lang="en-US" altLang="ja-JP" sz="1800" dirty="0" smtClean="0"/>
              <a:t>Data </a:t>
            </a:r>
            <a:r>
              <a:rPr lang="en-US" altLang="ja-JP" sz="1800" dirty="0"/>
              <a:t>are expressed as the means ± SD of </a:t>
            </a:r>
            <a:r>
              <a:rPr lang="en-US" altLang="ja-JP" sz="1800" dirty="0" smtClean="0"/>
              <a:t>4 </a:t>
            </a:r>
            <a:r>
              <a:rPr lang="en-US" altLang="ja-JP" sz="1800" dirty="0"/>
              <a:t>rats. </a:t>
            </a:r>
            <a:r>
              <a:rPr lang="en-US" altLang="ja-JP" sz="1800" dirty="0" smtClean="0"/>
              <a:t> </a:t>
            </a:r>
            <a:r>
              <a:rPr lang="en-US" altLang="ja-JP" sz="1800" dirty="0"/>
              <a:t>**, </a:t>
            </a:r>
            <a:r>
              <a:rPr lang="en-US" altLang="ja-JP" sz="1800" i="1" dirty="0"/>
              <a:t>P</a:t>
            </a:r>
            <a:r>
              <a:rPr lang="en-US" altLang="ja-JP" sz="1800" dirty="0"/>
              <a:t> &lt; 0.01 vs. WT or CNP-KO rats using Student’s </a:t>
            </a:r>
            <a:r>
              <a:rPr lang="en-US" altLang="ja-JP" sz="1800" i="1" dirty="0"/>
              <a:t>t</a:t>
            </a:r>
            <a:r>
              <a:rPr lang="en-US" altLang="ja-JP" sz="1800" dirty="0"/>
              <a:t>-test.</a:t>
            </a:r>
            <a:endParaRPr lang="ja-JP" altLang="ja-JP" sz="1600" dirty="0"/>
          </a:p>
        </p:txBody>
      </p:sp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858837" y="1241702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6769138"/>
              </p:ext>
            </p:extLst>
          </p:nvPr>
        </p:nvGraphicFramePr>
        <p:xfrm>
          <a:off x="1053480" y="2154766"/>
          <a:ext cx="6083920" cy="42015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テキスト ボックス 6"/>
          <p:cNvSpPr txBox="1"/>
          <p:nvPr/>
        </p:nvSpPr>
        <p:spPr>
          <a:xfrm rot="16200000">
            <a:off x="-361822" y="3535204"/>
            <a:ext cx="24413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 smtClean="0"/>
              <a:t>mRNA</a:t>
            </a:r>
            <a:r>
              <a:rPr lang="ja-JP" altLang="en-US" sz="2000" dirty="0"/>
              <a:t> </a:t>
            </a:r>
            <a:r>
              <a:rPr lang="en-US" altLang="ja-JP" sz="2000" dirty="0" smtClean="0"/>
              <a:t>fold change</a:t>
            </a:r>
            <a:endParaRPr kumimoji="1" lang="ja-JP" altLang="en-US" sz="2000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540000" y="4255558"/>
            <a:ext cx="1244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**</a:t>
            </a:r>
            <a:endParaRPr kumimoji="1" lang="ja-JP" altLang="en-US" dirty="0"/>
          </a:p>
        </p:txBody>
      </p:sp>
      <p:sp>
        <p:nvSpPr>
          <p:cNvPr id="11" name="正方形/長方形 10"/>
          <p:cNvSpPr/>
          <p:nvPr/>
        </p:nvSpPr>
        <p:spPr>
          <a:xfrm>
            <a:off x="6159500" y="2410883"/>
            <a:ext cx="216000" cy="21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正方形/長方形 11"/>
          <p:cNvSpPr/>
          <p:nvPr/>
        </p:nvSpPr>
        <p:spPr>
          <a:xfrm>
            <a:off x="6159500" y="2855383"/>
            <a:ext cx="216000" cy="216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6395450" y="2339458"/>
            <a:ext cx="13779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WT</a:t>
            </a:r>
            <a:endParaRPr kumimoji="1" lang="ja-JP" altLang="en-US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6395450" y="2771258"/>
            <a:ext cx="13779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CNP-KO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646601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34</TotalTime>
  <Words>9</Words>
  <Application>Microsoft Office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Supplement fig 2 Comparison of gene expression of Mgp, Ank and Npp1 between WT and CNP-KO rats.  RT-PCR of the mineralization inhibitor regulating genes, Mgp, Ank and Npp1 in lumber vertebra of 4-week-old female WT and CNP-KO rats. Data are expressed as the means ± SD of 4 rats.  **, P &lt; 0.01 vs. WT or CNP-KO rats using Student’s t-test.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NP KOラット論文2報目</dc:title>
  <dc:creator>hepatica0001@outlook.jp</dc:creator>
  <cp:lastModifiedBy>YOTSUMOTO TAKAFUMI / 四元 孝史</cp:lastModifiedBy>
  <cp:revision>177</cp:revision>
  <dcterms:created xsi:type="dcterms:W3CDTF">2017-12-20T06:34:36Z</dcterms:created>
  <dcterms:modified xsi:type="dcterms:W3CDTF">2019-04-16T07:40:46Z</dcterms:modified>
</cp:coreProperties>
</file>